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60" r:id="rId4"/>
    <p:sldId id="258" r:id="rId5"/>
    <p:sldId id="259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51" d="100"/>
          <a:sy n="51" d="100"/>
        </p:scale>
        <p:origin x="61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16ECDD-63C1-4E91-A0B3-DA50E073560F}" type="datetimeFigureOut">
              <a:rPr lang="en-AU" smtClean="0"/>
              <a:t>11/11/2025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982D9D6-4923-4DA6-97DD-3A7241AA687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417056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982D9D6-4923-4DA6-97DD-3A7241AA687F}" type="slidenum">
              <a:rPr lang="en-AU" smtClean="0"/>
              <a:t>5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034408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FFFD8B-9388-EEDB-4A6F-92D515D18F8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49AB3D1-8996-7A7F-F577-2C4D5F0C652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C4268A-C8CA-F2A6-88EE-187E42AB38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8C1AA-6901-401C-8A2D-65B4D7877D1E}" type="datetimeFigureOut">
              <a:rPr lang="en-AU" smtClean="0"/>
              <a:t>11/11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7E59CF-8D66-CF76-1CB3-1D8712A50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3B078F-1CB6-CC62-712E-92BF100344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A29D6-48E4-4B9D-86DE-DD17CBBDE5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322988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71A17E-C071-ADAA-4A7C-4C1CDC39B8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A82B0D6-B3DE-67CD-30E5-F7D11C1B43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F15DF5-2F6A-33FA-AE71-448AD8C405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8C1AA-6901-401C-8A2D-65B4D7877D1E}" type="datetimeFigureOut">
              <a:rPr lang="en-AU" smtClean="0"/>
              <a:t>11/11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B29169-FC95-7B1B-D48B-18D14D8BEB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9FC7E4-11BE-16BC-17CE-97D53760AF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A29D6-48E4-4B9D-86DE-DD17CBBDE5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927649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CFF8B94-BC5A-7B8D-7265-5FE3570017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16EEE9F-E4AD-80BA-EB3E-0FED077A81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B8C1AC-B921-1355-A636-7A057460CF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8C1AA-6901-401C-8A2D-65B4D7877D1E}" type="datetimeFigureOut">
              <a:rPr lang="en-AU" smtClean="0"/>
              <a:t>11/11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ACDE7F-2E14-9205-45D3-625C38AF49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4BDFE5-968B-B50F-4E50-D4DC0C5BCF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A29D6-48E4-4B9D-86DE-DD17CBBDE5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548490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B76FEA-080C-A4DC-BD76-51F8F75340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AA12C5-2F1F-3457-6F62-67F66237CB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AA0E3C-6311-DBDC-28AF-59FC7AF131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8C1AA-6901-401C-8A2D-65B4D7877D1E}" type="datetimeFigureOut">
              <a:rPr lang="en-AU" smtClean="0"/>
              <a:t>11/11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65178F-27B4-ED67-3F2F-7121F25508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53DB18-1285-E7C1-7AE7-03034C3527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A29D6-48E4-4B9D-86DE-DD17CBBDE5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670607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26E6A2-9868-A6E5-AA96-674ED64DAC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1B9E0F-6784-4EE2-558B-81E83555D0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BE2C6B-FC6F-1E4D-7B1F-8E65DAF6FE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8C1AA-6901-401C-8A2D-65B4D7877D1E}" type="datetimeFigureOut">
              <a:rPr lang="en-AU" smtClean="0"/>
              <a:t>11/11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1E9798-4359-4C05-7EC2-6924AC9F1D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14487E-F4AD-4122-EC8A-E07862AD61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A29D6-48E4-4B9D-86DE-DD17CBBDE5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38786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FAA345-E811-7101-AA8E-A33BBC3491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21280C-24A1-8687-D5E7-A8A40B6947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175B08-D2F1-385A-CFD4-6353C8AF2A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9BBBDA-1233-55F3-4591-B5BD831F72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8C1AA-6901-401C-8A2D-65B4D7877D1E}" type="datetimeFigureOut">
              <a:rPr lang="en-AU" smtClean="0"/>
              <a:t>11/11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55CD8B-4918-58FC-5DD1-31BD403948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FECB6B-5FC3-BCF8-97BF-FAE77F4208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A29D6-48E4-4B9D-86DE-DD17CBBDE5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19489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624CD5-9B29-EA72-AD7D-54538F7C4B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A6A18C-D5E0-9CD5-6212-50034DC056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C6D9F7C-FD08-8615-FF28-7A8DCEC58A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03759DA-E0F5-9E91-44B7-3242536637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4894C15-9D40-DC5F-3DD8-F8B7F6392FF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39F6B11-022E-024E-4FDB-30A9A1A696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8C1AA-6901-401C-8A2D-65B4D7877D1E}" type="datetimeFigureOut">
              <a:rPr lang="en-AU" smtClean="0"/>
              <a:t>11/11/2025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008334E-BC08-FC0F-C4BF-AE654F2FA4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5CAD273-F455-6A2C-14DF-44DB5872CC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A29D6-48E4-4B9D-86DE-DD17CBBDE5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211948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F17D74-365E-1DB8-AF79-B941DC97A2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3317577-6548-7DC2-8A0C-39C6B81BFB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8C1AA-6901-401C-8A2D-65B4D7877D1E}" type="datetimeFigureOut">
              <a:rPr lang="en-AU" smtClean="0"/>
              <a:t>11/11/2025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74EE018-9A78-C880-507E-C66FA053C3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E445992-95A3-8F69-04E5-3581F930B1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A29D6-48E4-4B9D-86DE-DD17CBBDE5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691323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EA0EBAF-55A8-7981-9716-F536552A41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8C1AA-6901-401C-8A2D-65B4D7877D1E}" type="datetimeFigureOut">
              <a:rPr lang="en-AU" smtClean="0"/>
              <a:t>11/11/2025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ADC2544-4CFD-C909-EBD6-E665303D3F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323BDBF-E55F-756A-27D6-67946716F4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A29D6-48E4-4B9D-86DE-DD17CBBDE5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614126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64F426-024F-3618-B804-C30F1967B4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8521C2-4094-9239-DCD7-E247DB2270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867E21-AD8A-F0D4-24B9-17AEBF5C0E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88034F-3190-FD4E-4E95-738173E436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8C1AA-6901-401C-8A2D-65B4D7877D1E}" type="datetimeFigureOut">
              <a:rPr lang="en-AU" smtClean="0"/>
              <a:t>11/11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4D494B-4807-332C-9DC9-B3E0C01434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17CBC9-9299-2700-6F30-03A71C9D98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A29D6-48E4-4B9D-86DE-DD17CBBDE5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937245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C44A00-B709-4A5C-430C-CA87C0826A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BA403C0-CDF0-3289-D75E-BAB3A8DF935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BF5C6A3-F7D0-DEA5-EA66-2D56A1FA16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687B17-00D4-7593-BF83-217523DFCD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8C1AA-6901-401C-8A2D-65B4D7877D1E}" type="datetimeFigureOut">
              <a:rPr lang="en-AU" smtClean="0"/>
              <a:t>11/11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D33FE3-C164-36F8-1CF2-8A201F3B31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E71C49-377B-7B60-E32E-DD008028E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CA29D6-48E4-4B9D-86DE-DD17CBBDE5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87207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AD56DF4-E2E1-0652-F555-6DB81FBFE1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90CB24-500F-20F7-1243-48B83C1566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72956A-965A-8C4A-3F46-D1FC8B9F7FD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278C1AA-6901-401C-8A2D-65B4D7877D1E}" type="datetimeFigureOut">
              <a:rPr lang="en-AU" smtClean="0"/>
              <a:t>11/11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F612CC-DDD8-A2EC-58D0-0F991A3D20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D5D6D7-D758-C91B-BAFF-4E747CC6042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2CA29D6-48E4-4B9D-86DE-DD17CBBDE5B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89437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emf"/><Relationship Id="rId4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F80702FF-E270-F6C7-9729-342AC1074E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57945" y="496541"/>
            <a:ext cx="5159446" cy="328497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2A77E862-4AF4-7972-12E8-1D0AFE11956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534" y="496541"/>
            <a:ext cx="4909841" cy="328269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DCF9E35-5359-D199-8F2C-45FABABF6156}"/>
              </a:ext>
            </a:extLst>
          </p:cNvPr>
          <p:cNvSpPr txBox="1"/>
          <p:nvPr/>
        </p:nvSpPr>
        <p:spPr>
          <a:xfrm>
            <a:off x="90534" y="63374"/>
            <a:ext cx="1166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Figure 5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F3CAE2A-2367-BCBC-990F-27A66E9C0F02}"/>
              </a:ext>
            </a:extLst>
          </p:cNvPr>
          <p:cNvSpPr txBox="1"/>
          <p:nvPr/>
        </p:nvSpPr>
        <p:spPr>
          <a:xfrm>
            <a:off x="6562253" y="63374"/>
            <a:ext cx="1166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Figure 6C</a:t>
            </a:r>
          </a:p>
        </p:txBody>
      </p:sp>
    </p:spTree>
    <p:extLst>
      <p:ext uri="{BB962C8B-B14F-4D97-AF65-F5344CB8AC3E}">
        <p14:creationId xmlns:p14="http://schemas.microsoft.com/office/powerpoint/2010/main" val="19160107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1BF3B9A6-ACF1-EF45-E616-59936631F5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955" y="739590"/>
            <a:ext cx="3179919" cy="342410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635DFD3-0EC0-F7DB-94E7-30EC48764D4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29338" y="739589"/>
            <a:ext cx="4433473" cy="342410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0931939-5715-3FF4-46BB-7DB2F9D2B286}"/>
              </a:ext>
            </a:extLst>
          </p:cNvPr>
          <p:cNvSpPr txBox="1"/>
          <p:nvPr/>
        </p:nvSpPr>
        <p:spPr>
          <a:xfrm>
            <a:off x="190122" y="27159"/>
            <a:ext cx="1145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Figure 7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01172E9-EF78-8E83-FD80-DCECC498D0F2}"/>
              </a:ext>
            </a:extLst>
          </p:cNvPr>
          <p:cNvSpPr txBox="1"/>
          <p:nvPr/>
        </p:nvSpPr>
        <p:spPr>
          <a:xfrm>
            <a:off x="5086538" y="27159"/>
            <a:ext cx="1145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Figure 7B</a:t>
            </a:r>
          </a:p>
        </p:txBody>
      </p:sp>
    </p:spTree>
    <p:extLst>
      <p:ext uri="{BB962C8B-B14F-4D97-AF65-F5344CB8AC3E}">
        <p14:creationId xmlns:p14="http://schemas.microsoft.com/office/powerpoint/2010/main" val="8310602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4715662F-D0E7-56AA-C11A-E7BC7BE8153C}"/>
              </a:ext>
            </a:extLst>
          </p:cNvPr>
          <p:cNvSpPr txBox="1"/>
          <p:nvPr/>
        </p:nvSpPr>
        <p:spPr>
          <a:xfrm>
            <a:off x="404546" y="73654"/>
            <a:ext cx="1145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Figure 8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81D7EBF-6890-5B3E-50ED-862407F47B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4546" y="572675"/>
            <a:ext cx="7299953" cy="31992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81083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close-up of a grey circle&#10;&#10;AI-generated content may be incorrect.">
            <a:extLst>
              <a:ext uri="{FF2B5EF4-FFF2-40B4-BE49-F238E27FC236}">
                <a16:creationId xmlns:a16="http://schemas.microsoft.com/office/drawing/2014/main" id="{A6785B82-78FF-BBBC-9181-3C5F5C58BAA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-696179" y="2725414"/>
            <a:ext cx="5029200" cy="249555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DA51D151-45FF-C8D7-B0E7-38B10F2885A3}"/>
              </a:ext>
            </a:extLst>
          </p:cNvPr>
          <p:cNvSpPr txBox="1"/>
          <p:nvPr/>
        </p:nvSpPr>
        <p:spPr>
          <a:xfrm>
            <a:off x="3066196" y="4087098"/>
            <a:ext cx="34425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iRNA (4x technical replications)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6BA22E1-B165-0742-FAE8-6CBF5A9CE009}"/>
              </a:ext>
            </a:extLst>
          </p:cNvPr>
          <p:cNvSpPr txBox="1"/>
          <p:nvPr/>
        </p:nvSpPr>
        <p:spPr>
          <a:xfrm>
            <a:off x="3055309" y="2595756"/>
            <a:ext cx="34425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iRNA (4x technical replications)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B337326-68E8-8FD4-8DB2-EEA1FA174B3E}"/>
              </a:ext>
            </a:extLst>
          </p:cNvPr>
          <p:cNvSpPr txBox="1"/>
          <p:nvPr/>
        </p:nvSpPr>
        <p:spPr>
          <a:xfrm>
            <a:off x="3044930" y="5894632"/>
            <a:ext cx="34425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iRNA (4x technical replications)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9BFBF22-6D27-E36B-C27F-0738BEE9678A}"/>
              </a:ext>
            </a:extLst>
          </p:cNvPr>
          <p:cNvSpPr txBox="1"/>
          <p:nvPr/>
        </p:nvSpPr>
        <p:spPr>
          <a:xfrm>
            <a:off x="3055309" y="1768440"/>
            <a:ext cx="3767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Off target (4x technical replications)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B0A1AC2-3340-6C16-73E8-F0F7BFD9929F}"/>
              </a:ext>
            </a:extLst>
          </p:cNvPr>
          <p:cNvSpPr txBox="1"/>
          <p:nvPr/>
        </p:nvSpPr>
        <p:spPr>
          <a:xfrm>
            <a:off x="3055309" y="5203665"/>
            <a:ext cx="3767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Off target (4x technical replications)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2663B1E-883C-0244-4FCD-5242D755D770}"/>
              </a:ext>
            </a:extLst>
          </p:cNvPr>
          <p:cNvSpPr txBox="1"/>
          <p:nvPr/>
        </p:nvSpPr>
        <p:spPr>
          <a:xfrm>
            <a:off x="3045561" y="3374865"/>
            <a:ext cx="3767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Off target (4x technical replications)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1ABB564-9795-E637-BFCB-1A7F1C220029}"/>
              </a:ext>
            </a:extLst>
          </p:cNvPr>
          <p:cNvSpPr txBox="1"/>
          <p:nvPr/>
        </p:nvSpPr>
        <p:spPr>
          <a:xfrm>
            <a:off x="518383" y="1089257"/>
            <a:ext cx="2647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3x biological replication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E1DA900-091C-4496-5753-E014D39A9A69}"/>
              </a:ext>
            </a:extLst>
          </p:cNvPr>
          <p:cNvSpPr txBox="1"/>
          <p:nvPr/>
        </p:nvSpPr>
        <p:spPr>
          <a:xfrm>
            <a:off x="517481" y="722902"/>
            <a:ext cx="222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RADAR assay; Top2</a:t>
            </a:r>
            <a:r>
              <a:rPr lang="el-GR" dirty="0">
                <a:latin typeface="Aptos" panose="020B0004020202020204" pitchFamily="34" charset="0"/>
              </a:rPr>
              <a:t>β</a:t>
            </a:r>
            <a:endParaRPr lang="en-AU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E067728-2231-D7CC-4B90-C38EEBBDF8D9}"/>
              </a:ext>
            </a:extLst>
          </p:cNvPr>
          <p:cNvSpPr txBox="1"/>
          <p:nvPr/>
        </p:nvSpPr>
        <p:spPr>
          <a:xfrm>
            <a:off x="461696" y="168904"/>
            <a:ext cx="1166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Figure 8C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C5EAEDF-C35F-1CC8-A3B4-149B9206F088}"/>
              </a:ext>
            </a:extLst>
          </p:cNvPr>
          <p:cNvSpPr txBox="1"/>
          <p:nvPr/>
        </p:nvSpPr>
        <p:spPr>
          <a:xfrm>
            <a:off x="-28575" y="1458589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Rep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00FA932-9BB7-611F-8597-0F03D225113F}"/>
              </a:ext>
            </a:extLst>
          </p:cNvPr>
          <p:cNvSpPr txBox="1"/>
          <p:nvPr/>
        </p:nvSpPr>
        <p:spPr>
          <a:xfrm>
            <a:off x="-57150" y="3163689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Rep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0933738-069A-9FC3-8E70-D5D0FDCF8BBE}"/>
              </a:ext>
            </a:extLst>
          </p:cNvPr>
          <p:cNvSpPr txBox="1"/>
          <p:nvPr/>
        </p:nvSpPr>
        <p:spPr>
          <a:xfrm>
            <a:off x="-38527" y="4959030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Rep3</a:t>
            </a:r>
          </a:p>
        </p:txBody>
      </p:sp>
    </p:spTree>
    <p:extLst>
      <p:ext uri="{BB962C8B-B14F-4D97-AF65-F5344CB8AC3E}">
        <p14:creationId xmlns:p14="http://schemas.microsoft.com/office/powerpoint/2010/main" val="38945125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D936C09-A2CF-DBDC-B828-CFFAD1D403C8}"/>
              </a:ext>
            </a:extLst>
          </p:cNvPr>
          <p:cNvSpPr txBox="1"/>
          <p:nvPr/>
        </p:nvSpPr>
        <p:spPr>
          <a:xfrm>
            <a:off x="461696" y="168904"/>
            <a:ext cx="1166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Figure 8D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FEEE4BF-5615-9E39-2327-5967BDFF10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7481" y="1661083"/>
            <a:ext cx="2708072" cy="111061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C423FA2-8BB5-2533-6F23-66EDEDC1C57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7481" y="2928279"/>
            <a:ext cx="2559094" cy="115802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615DD80-1A9B-33AD-40AD-CA6ED776B66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05634" y="4593987"/>
            <a:ext cx="4978444" cy="158089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C2A8C42-AF7E-BBC7-DD64-B58DF27CCF4C}"/>
              </a:ext>
            </a:extLst>
          </p:cNvPr>
          <p:cNvSpPr txBox="1"/>
          <p:nvPr/>
        </p:nvSpPr>
        <p:spPr>
          <a:xfrm>
            <a:off x="2668497" y="702493"/>
            <a:ext cx="2647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3x biological replication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3D229CE-2BC1-9C4C-A763-F9E2D7910D4B}"/>
              </a:ext>
            </a:extLst>
          </p:cNvPr>
          <p:cNvSpPr txBox="1"/>
          <p:nvPr/>
        </p:nvSpPr>
        <p:spPr>
          <a:xfrm>
            <a:off x="446607" y="702493"/>
            <a:ext cx="2287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RADAR assay; Top2</a:t>
            </a:r>
            <a:r>
              <a:rPr lang="el-GR" dirty="0">
                <a:latin typeface="Aptos" panose="020B0004020202020204" pitchFamily="34" charset="0"/>
              </a:rPr>
              <a:t>β</a:t>
            </a:r>
            <a:r>
              <a:rPr lang="en-AU" dirty="0">
                <a:latin typeface="Aptos" panose="020B0004020202020204" pitchFamily="34" charset="0"/>
              </a:rPr>
              <a:t>;</a:t>
            </a:r>
            <a:endParaRPr lang="en-AU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E114160-FF78-D7E9-D413-90EAFF8D98E3}"/>
              </a:ext>
            </a:extLst>
          </p:cNvPr>
          <p:cNvSpPr txBox="1"/>
          <p:nvPr/>
        </p:nvSpPr>
        <p:spPr>
          <a:xfrm>
            <a:off x="3158878" y="1884514"/>
            <a:ext cx="4561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Wild-type TDP-43 (4x technical replications)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2285E39-5618-CE3B-C3E3-B6F886D2556A}"/>
              </a:ext>
            </a:extLst>
          </p:cNvPr>
          <p:cNvSpPr txBox="1"/>
          <p:nvPr/>
        </p:nvSpPr>
        <p:spPr>
          <a:xfrm>
            <a:off x="3031902" y="3001903"/>
            <a:ext cx="4561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Wild-type TDP-43 (4x technical replications)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C55D8BE-8435-1A00-8E29-3D2D5F0B531A}"/>
              </a:ext>
            </a:extLst>
          </p:cNvPr>
          <p:cNvSpPr txBox="1"/>
          <p:nvPr/>
        </p:nvSpPr>
        <p:spPr>
          <a:xfrm>
            <a:off x="3158878" y="2318277"/>
            <a:ext cx="4090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A90V TDP-43 (4x technical replications)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78DD2F9-485C-C853-5370-8476664738F0}"/>
              </a:ext>
            </a:extLst>
          </p:cNvPr>
          <p:cNvSpPr txBox="1"/>
          <p:nvPr/>
        </p:nvSpPr>
        <p:spPr>
          <a:xfrm>
            <a:off x="3031902" y="3573156"/>
            <a:ext cx="4090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A90V TDP-43 (4x technical replications)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22D3D4D-B4F8-991D-DE58-DB142B300289}"/>
              </a:ext>
            </a:extLst>
          </p:cNvPr>
          <p:cNvSpPr txBox="1"/>
          <p:nvPr/>
        </p:nvSpPr>
        <p:spPr>
          <a:xfrm>
            <a:off x="7121932" y="4658418"/>
            <a:ext cx="4090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A90V TDP-43 (4x technical replications)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CAF9DE7-7A54-0819-CA6B-9B8DDBFDEEA1}"/>
              </a:ext>
            </a:extLst>
          </p:cNvPr>
          <p:cNvSpPr txBox="1"/>
          <p:nvPr/>
        </p:nvSpPr>
        <p:spPr>
          <a:xfrm>
            <a:off x="212681" y="4786905"/>
            <a:ext cx="4561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Wild-type TDP-43 (4x technical replications)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692AECC-30B2-BFB4-2620-9C3286088301}"/>
              </a:ext>
            </a:extLst>
          </p:cNvPr>
          <p:cNvSpPr txBox="1"/>
          <p:nvPr/>
        </p:nvSpPr>
        <p:spPr>
          <a:xfrm>
            <a:off x="212681" y="5439855"/>
            <a:ext cx="4561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Wild-type TDP-43 (4x technical replications)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65AEE97-C7CC-7BDC-2650-25842371B478}"/>
              </a:ext>
            </a:extLst>
          </p:cNvPr>
          <p:cNvSpPr txBox="1"/>
          <p:nvPr/>
        </p:nvSpPr>
        <p:spPr>
          <a:xfrm>
            <a:off x="42596" y="1430506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Rep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F298313-2DE6-8942-153C-F0942489B0E7}"/>
              </a:ext>
            </a:extLst>
          </p:cNvPr>
          <p:cNvSpPr txBox="1"/>
          <p:nvPr/>
        </p:nvSpPr>
        <p:spPr>
          <a:xfrm>
            <a:off x="42596" y="2728839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Rep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5500800-A720-FB87-4CE5-302A9E000E6B}"/>
              </a:ext>
            </a:extLst>
          </p:cNvPr>
          <p:cNvSpPr txBox="1"/>
          <p:nvPr/>
        </p:nvSpPr>
        <p:spPr>
          <a:xfrm>
            <a:off x="4571338" y="4318621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Rep3</a:t>
            </a:r>
          </a:p>
        </p:txBody>
      </p:sp>
    </p:spTree>
    <p:extLst>
      <p:ext uri="{BB962C8B-B14F-4D97-AF65-F5344CB8AC3E}">
        <p14:creationId xmlns:p14="http://schemas.microsoft.com/office/powerpoint/2010/main" val="9907910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0</TotalTime>
  <Words>126</Words>
  <Application>Microsoft Office PowerPoint</Application>
  <PresentationFormat>Widescreen</PresentationFormat>
  <Paragraphs>31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na Konopka</dc:creator>
  <cp:lastModifiedBy>Anna Konopka</cp:lastModifiedBy>
  <cp:revision>30</cp:revision>
  <dcterms:created xsi:type="dcterms:W3CDTF">2025-11-01T06:14:47Z</dcterms:created>
  <dcterms:modified xsi:type="dcterms:W3CDTF">2025-11-11T03:56:02Z</dcterms:modified>
</cp:coreProperties>
</file>